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040" y="-462"/>
      </p:cViewPr>
      <p:guideLst>
        <p:guide orient="horz" pos="4247"/>
        <p:guide pos="3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33E7F2-AB72-4180-B71B-5C77E8D4702E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4A3B6F-22E3-4059-9782-CD3563A8C61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2328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4A3B6F-22E3-4059-9782-CD3563A8C613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366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1213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4016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7633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432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5238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965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5698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3319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6375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946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909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8621E-4723-4097-9761-A4DFD3B3881B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1C9A7-DD92-4F60-9C9D-23302DE368B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8294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hteck 30"/>
          <p:cNvSpPr/>
          <p:nvPr/>
        </p:nvSpPr>
        <p:spPr>
          <a:xfrm>
            <a:off x="1187624" y="329319"/>
            <a:ext cx="66762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Rsi</a:t>
            </a:r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730" y="2319842"/>
            <a:ext cx="1737360" cy="1737360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613730" y="2320798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x37</a:t>
            </a:r>
            <a:endParaRPr lang="de-DE" sz="11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33" name="Grafik 32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4879" y="2319842"/>
            <a:ext cx="1737360" cy="1737360"/>
          </a:xfrm>
          <a:prstGeom prst="rect">
            <a:avLst/>
          </a:prstGeom>
        </p:spPr>
      </p:pic>
      <p:sp>
        <p:nvSpPr>
          <p:cNvPr id="37" name="Rechteck 36"/>
          <p:cNvSpPr/>
          <p:nvPr/>
        </p:nvSpPr>
        <p:spPr>
          <a:xfrm>
            <a:off x="2844754" y="329319"/>
            <a:ext cx="65421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siCx43</a:t>
            </a:r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820" y="544763"/>
            <a:ext cx="1737360" cy="1737360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613730" y="544763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x43</a:t>
            </a:r>
            <a:endParaRPr lang="de-DE" sz="11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Gerade Verbindung 40"/>
          <p:cNvCxnSpPr/>
          <p:nvPr/>
        </p:nvCxnSpPr>
        <p:spPr>
          <a:xfrm>
            <a:off x="1998853" y="219559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Grafik 33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4879" y="544763"/>
            <a:ext cx="1737360" cy="1737360"/>
          </a:xfrm>
          <a:prstGeom prst="rect">
            <a:avLst/>
          </a:prstGeom>
        </p:spPr>
      </p:pic>
      <p:cxnSp>
        <p:nvCxnSpPr>
          <p:cNvPr id="36" name="Gerade Verbindung 35"/>
          <p:cNvCxnSpPr/>
          <p:nvPr/>
        </p:nvCxnSpPr>
        <p:spPr>
          <a:xfrm>
            <a:off x="3787230" y="219559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V="1">
            <a:off x="1619672" y="1646802"/>
            <a:ext cx="117786" cy="72008"/>
          </a:xfrm>
          <a:prstGeom prst="straightConnector1">
            <a:avLst/>
          </a:prstGeom>
          <a:ln w="9525" cap="flat">
            <a:solidFill>
              <a:schemeClr val="bg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V="1">
            <a:off x="971600" y="1314262"/>
            <a:ext cx="166996" cy="36004"/>
          </a:xfrm>
          <a:prstGeom prst="straightConnector1">
            <a:avLst/>
          </a:prstGeom>
          <a:ln w="9525" cap="flat">
            <a:solidFill>
              <a:schemeClr val="bg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7984" y="544763"/>
            <a:ext cx="1738800" cy="173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9647" y="2319842"/>
            <a:ext cx="1738800" cy="173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Rechteck 25"/>
          <p:cNvSpPr/>
          <p:nvPr/>
        </p:nvSpPr>
        <p:spPr>
          <a:xfrm>
            <a:off x="4963573" y="329319"/>
            <a:ext cx="66762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Rsi</a:t>
            </a:r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4439647" y="553737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x43</a:t>
            </a:r>
            <a:endParaRPr lang="de-DE" sz="11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445780" y="2319842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x40</a:t>
            </a:r>
            <a:endParaRPr lang="de-DE" sz="11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9016" y="544763"/>
            <a:ext cx="173736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9016" y="2321282"/>
            <a:ext cx="173736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Rechteck 41"/>
          <p:cNvSpPr/>
          <p:nvPr/>
        </p:nvSpPr>
        <p:spPr>
          <a:xfrm>
            <a:off x="6753885" y="329319"/>
            <a:ext cx="66762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siCx43</a:t>
            </a:r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Gerade Verbindung 42"/>
          <p:cNvCxnSpPr/>
          <p:nvPr/>
        </p:nvCxnSpPr>
        <p:spPr>
          <a:xfrm>
            <a:off x="5815156" y="219559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43"/>
          <p:cNvCxnSpPr/>
          <p:nvPr/>
        </p:nvCxnSpPr>
        <p:spPr>
          <a:xfrm>
            <a:off x="7596336" y="219559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613819" y="4396462"/>
            <a:ext cx="73425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. 1: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duc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x43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hang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x37/Cx40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dotheli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HUVEC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si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x43 (siCx43).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r: 20 µm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Gerade Verbindung mit Pfeil 48"/>
          <p:cNvCxnSpPr/>
          <p:nvPr/>
        </p:nvCxnSpPr>
        <p:spPr>
          <a:xfrm flipV="1">
            <a:off x="5130387" y="1296260"/>
            <a:ext cx="166996" cy="36004"/>
          </a:xfrm>
          <a:prstGeom prst="straightConnector1">
            <a:avLst/>
          </a:prstGeom>
          <a:ln w="9525" cap="flat">
            <a:solidFill>
              <a:schemeClr val="bg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V="1">
            <a:off x="5631194" y="1700808"/>
            <a:ext cx="166996" cy="36004"/>
          </a:xfrm>
          <a:prstGeom prst="straightConnector1">
            <a:avLst/>
          </a:prstGeom>
          <a:ln w="9525" cap="flat">
            <a:solidFill>
              <a:schemeClr val="bg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/>
          <p:cNvSpPr/>
          <p:nvPr/>
        </p:nvSpPr>
        <p:spPr>
          <a:xfrm>
            <a:off x="169611" y="6381328"/>
            <a:ext cx="19732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385898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Bildschirmpräsentation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ogoda</dc:creator>
  <cp:lastModifiedBy>Petra_zuhause</cp:lastModifiedBy>
  <cp:revision>25</cp:revision>
  <cp:lastPrinted>2014-03-10T12:00:33Z</cp:lastPrinted>
  <dcterms:created xsi:type="dcterms:W3CDTF">2014-02-14T13:11:18Z</dcterms:created>
  <dcterms:modified xsi:type="dcterms:W3CDTF">2014-03-10T21:52:48Z</dcterms:modified>
</cp:coreProperties>
</file>